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DB10B2-D311-41BB-BBF4-7063DD8A77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1B9D6-25F3-4EB1-8789-F4528F0514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A8EE2B-4DA6-471B-A1EE-984B1F8501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D6BE7F-88CA-4CD2-902C-E38B2F634E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AD6B8-4280-4B45-92C1-D3EFB35220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9EB5B-BDF5-4C4B-950F-B3331F471C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7DE8B-49E2-4FBE-9DDA-7BEA375F32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7A9C3-FDC0-4AAF-9054-EF7DA5005E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144D6-E754-4138-AFB2-EB83913BE0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B4810-07AF-4915-8242-F8778C8C34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32DF5-05CA-464C-AD4D-7E715F5FFC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167C9-211B-4660-A235-764E331EDB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15F0D8-5B8F-4308-B45C-0B02B754D35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5"/>
          <p:cNvGrpSpPr/>
          <p:nvPr/>
        </p:nvGrpSpPr>
        <p:grpSpPr>
          <a:xfrm>
            <a:off x="1989000" y="3008160"/>
            <a:ext cx="3024000" cy="2951280"/>
            <a:chOff x="1989000" y="3008160"/>
            <a:chExt cx="3024000" cy="2951280"/>
          </a:xfrm>
        </p:grpSpPr>
        <p:sp>
          <p:nvSpPr>
            <p:cNvPr id="42" name="Rectangle 6"/>
            <p:cNvSpPr/>
            <p:nvPr/>
          </p:nvSpPr>
          <p:spPr>
            <a:xfrm>
              <a:off x="1989000" y="3008160"/>
              <a:ext cx="3024000" cy="295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ine 7"/>
            <p:cNvSpPr/>
            <p:nvPr/>
          </p:nvSpPr>
          <p:spPr>
            <a:xfrm>
              <a:off x="3068280" y="3008160"/>
              <a:ext cx="1800" cy="295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8"/>
            <p:cNvSpPr/>
            <p:nvPr/>
          </p:nvSpPr>
          <p:spPr>
            <a:xfrm>
              <a:off x="2992680" y="3092400"/>
              <a:ext cx="1878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oiled-coil probabiliti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      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n pUL7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9"/>
            <p:cNvSpPr/>
            <p:nvPr/>
          </p:nvSpPr>
          <p:spPr>
            <a:xfrm flipV="1">
              <a:off x="1989000" y="3582360"/>
              <a:ext cx="302400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10"/>
            <p:cNvSpPr/>
            <p:nvPr/>
          </p:nvSpPr>
          <p:spPr>
            <a:xfrm>
              <a:off x="2053080" y="3093840"/>
              <a:ext cx="89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rogram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1"/>
            <p:cNvSpPr/>
            <p:nvPr/>
          </p:nvSpPr>
          <p:spPr>
            <a:xfrm>
              <a:off x="3805920" y="4173480"/>
              <a:ext cx="534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++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2"/>
            <p:cNvSpPr/>
            <p:nvPr/>
          </p:nvSpPr>
          <p:spPr>
            <a:xfrm>
              <a:off x="2133000" y="4230360"/>
              <a:ext cx="49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3"/>
            <p:cNvSpPr/>
            <p:nvPr/>
          </p:nvSpPr>
          <p:spPr>
            <a:xfrm>
              <a:off x="2132640" y="4676760"/>
              <a:ext cx="639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OI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4"/>
            <p:cNvSpPr/>
            <p:nvPr/>
          </p:nvSpPr>
          <p:spPr>
            <a:xfrm>
              <a:off x="3878640" y="4676760"/>
              <a:ext cx="44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+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5"/>
            <p:cNvSpPr/>
            <p:nvPr/>
          </p:nvSpPr>
          <p:spPr>
            <a:xfrm>
              <a:off x="2061720" y="5167080"/>
              <a:ext cx="933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ATCH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6"/>
            <p:cNvSpPr/>
            <p:nvPr/>
          </p:nvSpPr>
          <p:spPr>
            <a:xfrm>
              <a:off x="3878640" y="5167080"/>
              <a:ext cx="44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+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7"/>
            <p:cNvSpPr/>
            <p:nvPr/>
          </p:nvSpPr>
          <p:spPr>
            <a:xfrm>
              <a:off x="2108520" y="5613120"/>
              <a:ext cx="67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Marcoi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8"/>
            <p:cNvSpPr/>
            <p:nvPr/>
          </p:nvSpPr>
          <p:spPr>
            <a:xfrm>
              <a:off x="3880440" y="5613120"/>
              <a:ext cx="44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+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9"/>
            <p:cNvSpPr/>
            <p:nvPr/>
          </p:nvSpPr>
          <p:spPr>
            <a:xfrm>
              <a:off x="2041920" y="3740040"/>
              <a:ext cx="74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COI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20"/>
            <p:cNvSpPr/>
            <p:nvPr/>
          </p:nvSpPr>
          <p:spPr>
            <a:xfrm>
              <a:off x="3791880" y="3740040"/>
              <a:ext cx="534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++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Text Box 21"/>
          <p:cNvSpPr/>
          <p:nvPr/>
        </p:nvSpPr>
        <p:spPr>
          <a:xfrm>
            <a:off x="212400" y="216000"/>
            <a:ext cx="1600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ure Supplement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eissn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5T15:25:13Z</dcterms:created>
  <dc:creator>ebogner</dc:creator>
  <dc:description/>
  <dc:language>en-US</dc:language>
  <cp:lastModifiedBy>ebogner</cp:lastModifiedBy>
  <dcterms:modified xsi:type="dcterms:W3CDTF">2011-09-12T06:26:29Z</dcterms:modified>
  <cp:revision>4</cp:revision>
  <dc:subject/>
  <dc:title>Folie 1</dc:title>
</cp:coreProperties>
</file>